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64" d="100"/>
          <a:sy n="64" d="100"/>
        </p:scale>
        <p:origin x="978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C056B9A-2D0E-0525-B170-6B4B41C664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128B232-379C-EE47-151B-C665829A40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53C9123-5C5C-12BC-F94D-6BBC3400AF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F13B1-4E68-4E7A-B894-FF1DCD2F6F99}" type="datetimeFigureOut">
              <a:rPr lang="es-ES" smtClean="0"/>
              <a:t>11/01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DB57024-99A8-F268-09BF-453E874CD1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A60D051-057C-B03F-04DF-FAF3A17D3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2CDB9-E3B8-4A8E-9ACE-8E7BA65E7A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8508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16356CC-90C8-9717-023A-52CA526F7F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C23A1A73-E6C4-011D-6674-2DE0FFBB4D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8B3A34E-8CF3-BA5A-A195-64EDD96058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F13B1-4E68-4E7A-B894-FF1DCD2F6F99}" type="datetimeFigureOut">
              <a:rPr lang="es-ES" smtClean="0"/>
              <a:t>11/01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1576492-FF16-CB7C-3353-32C55FAE4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78E6EE5-34D3-8B1B-0BDF-2BC3CD6537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2CDB9-E3B8-4A8E-9ACE-8E7BA65E7A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6134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5973A21-5DBA-892F-A3B9-D8AA4866B5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C26C67A-FC2C-407C-B456-664CE467A7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547F5CE-FF6E-6D76-527E-57A7413D5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F13B1-4E68-4E7A-B894-FF1DCD2F6F99}" type="datetimeFigureOut">
              <a:rPr lang="es-ES" smtClean="0"/>
              <a:t>11/01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C93DB9A-9C8A-2F97-5861-FD62EECEF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0865C62-B08B-2714-EEFC-663B96D73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2CDB9-E3B8-4A8E-9ACE-8E7BA65E7A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084497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A187A81-F105-27CA-2C1E-F4662F27B3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08C4227-D6DE-E084-FD90-CD74FC5D00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1C395B0-9963-A4DF-3F6D-26AE4E89E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F13B1-4E68-4E7A-B894-FF1DCD2F6F99}" type="datetimeFigureOut">
              <a:rPr lang="es-ES" smtClean="0"/>
              <a:t>11/01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64E2D20-7AD6-36C5-2165-00C1478CFB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AF8D32E-2F36-1265-43BE-42B0E382CB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2CDB9-E3B8-4A8E-9ACE-8E7BA65E7A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6385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EB8978F-34E3-85F7-5D4A-42DA1C96C2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7B43BB9-00CC-85E9-20FF-CA24256655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5D7829A-566C-EB03-7FDC-6A6F18224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F13B1-4E68-4E7A-B894-FF1DCD2F6F99}" type="datetimeFigureOut">
              <a:rPr lang="es-ES" smtClean="0"/>
              <a:t>11/01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31D3209-4EEF-3F0F-3AF3-9579268307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53DAC26F-70C4-62BF-AD97-99891723C5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2CDB9-E3B8-4A8E-9ACE-8E7BA65E7A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8236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E9F21B-7CCC-28C7-7B23-5A3BE94BE3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05D9D93-9C3D-9E8A-C775-68DA4B5603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1502A73-4D62-3F1F-AFB6-8B113BE359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A1C6E84-F35C-B1BF-F8B0-44D3040DE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F13B1-4E68-4E7A-B894-FF1DCD2F6F99}" type="datetimeFigureOut">
              <a:rPr lang="es-ES" smtClean="0"/>
              <a:t>11/01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9944178C-11AF-F3B3-9B66-A165BB0D3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9CD9D43-AA72-BDBD-D5C0-D949C0E57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2CDB9-E3B8-4A8E-9ACE-8E7BA65E7A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1489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BD965AD-FE50-BD7A-7D34-F1D4E5ED18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FD69801-342C-FDCD-7755-66BAE2D5D2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EA1D7B2-C1B4-C0B7-AEDA-37E46E56D3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898287F4-8E75-E7BA-2ADA-5ACC7DE202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A25BA86-97BA-24FF-5879-2CF0EA9940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968E64D-4BD0-D56A-EDFF-CBE57425D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F13B1-4E68-4E7A-B894-FF1DCD2F6F99}" type="datetimeFigureOut">
              <a:rPr lang="es-ES" smtClean="0"/>
              <a:t>11/01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8BD115CA-8B9C-F028-FEF6-9450C56FD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0503CF19-7863-304F-0798-D5AAC047B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2CDB9-E3B8-4A8E-9ACE-8E7BA65E7A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27554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DE796F2-6924-47DD-E50C-C0C5A6BC75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E77E5D22-8C28-FE0E-22A9-23A2EA3A50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F13B1-4E68-4E7A-B894-FF1DCD2F6F99}" type="datetimeFigureOut">
              <a:rPr lang="es-ES" smtClean="0"/>
              <a:t>11/01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0037F88E-268A-8417-D437-7FE03FC093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DFF08E35-4F6E-AC6E-F597-C1FEAA1D2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2CDB9-E3B8-4A8E-9ACE-8E7BA65E7A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37216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864211D-7064-1601-B930-984315C1E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F13B1-4E68-4E7A-B894-FF1DCD2F6F99}" type="datetimeFigureOut">
              <a:rPr lang="es-ES" smtClean="0"/>
              <a:t>11/01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45E1AC7C-F79E-8A5F-BF73-A73F34F83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43BA2CA-F3C5-B82D-97FF-A685A51A3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2CDB9-E3B8-4A8E-9ACE-8E7BA65E7A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6447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D7EED01-5E01-0468-84AF-255EE06123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B1D7CA6-AB20-F82B-7EAB-24C5F80BCC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CF4B92EF-6E24-E2A8-B079-F6452FBBDC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D2E7F5C-9BEE-5C4D-E4F8-26FA930E3B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F13B1-4E68-4E7A-B894-FF1DCD2F6F99}" type="datetimeFigureOut">
              <a:rPr lang="es-ES" smtClean="0"/>
              <a:t>11/01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F12E602F-193F-CC00-AF15-16B3FE462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5339A415-15B1-691A-657F-42A0693715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2CDB9-E3B8-4A8E-9ACE-8E7BA65E7A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3727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981024C-CF73-62A1-1419-2358FC3A83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F777BBA9-E9BF-A4DF-8CC7-FDB475198C3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D7BAFE39-230F-1939-39C9-3FA4691C3A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7843EBD-ACB4-0D6C-63FB-5DC267C58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0F13B1-4E68-4E7A-B894-FF1DCD2F6F99}" type="datetimeFigureOut">
              <a:rPr lang="es-ES" smtClean="0"/>
              <a:t>11/01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9A893E9-2939-2A49-709B-FC3B2FA3FC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EC25F17-1AB7-7BE9-9F5D-FC404E34C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2CDB9-E3B8-4A8E-9ACE-8E7BA65E7A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11954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89AC5D6E-79D7-FCDB-B768-B3EA5CEC81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0DEA4FD-D5F5-BA04-DD91-463F3848A7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C660A67-50FF-EAC4-4BBA-705508615B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70F13B1-4E68-4E7A-B894-FF1DCD2F6F99}" type="datetimeFigureOut">
              <a:rPr lang="es-ES" smtClean="0"/>
              <a:t>11/01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5465E71-22DA-7744-71D3-F5CE5070C3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099C071-D7C4-3DFA-04F8-158010D5D1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D2CDB9-E3B8-4A8E-9ACE-8E7BA65E7AC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77175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AB866060-49EA-DC26-9B86-A86F3217EDD7}"/>
              </a:ext>
            </a:extLst>
          </p:cNvPr>
          <p:cNvSpPr txBox="1"/>
          <p:nvPr/>
        </p:nvSpPr>
        <p:spPr>
          <a:xfrm>
            <a:off x="3047189" y="3241962"/>
            <a:ext cx="6094378" cy="3740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information</a:t>
            </a:r>
            <a:endParaRPr lang="es-ES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49410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EBB288C9-A5C7-BB15-6DDD-875A4E56A4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pic>
        <p:nvPicPr>
          <p:cNvPr id="1025" name="Imagen 6">
            <a:extLst>
              <a:ext uri="{FF2B5EF4-FFF2-40B4-BE49-F238E27FC236}">
                <a16:creationId xmlns:a16="http://schemas.microsoft.com/office/drawing/2014/main" id="{2B9BE1A6-C7BA-C011-BD3F-776C1034670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2408" y="792804"/>
            <a:ext cx="5943600" cy="40671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B6F22244-601B-9488-D864-1C2EEC0888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90657" y="5102331"/>
            <a:ext cx="6719141" cy="11233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E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endParaRPr kumimoji="0" lang="es-ES" altLang="es-E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s-E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1.  Analysis of primer efficiency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(A). Individual graphs for </a:t>
            </a:r>
            <a:r>
              <a:rPr lang="en-US" altLang="es-E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imer 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fficiency of </a:t>
            </a:r>
            <a:r>
              <a:rPr kumimoji="0" lang="en-US" altLang="es-E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nActin7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kumimoji="0" lang="en-US" altLang="es-E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nCAT1,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es-ES" sz="11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nSOD</a:t>
            </a:r>
            <a:r>
              <a:rPr kumimoji="0" lang="en-US" altLang="es-E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kumimoji="0" lang="en-US" altLang="es-ES" sz="1100" b="0" i="1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nAPX</a:t>
            </a:r>
            <a:r>
              <a:rPr kumimoji="0" lang="en-US" altLang="es-E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es-E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nATG8D,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es-E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nEXO70B,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es-E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nNBR1</a:t>
            </a:r>
            <a:r>
              <a:rPr lang="en-US" altLang="es-ES" sz="11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altLang="es-ES" sz="1100" i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kumimoji="0" lang="en-US" altLang="es-ES" sz="1100" b="0" i="1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nATI1 </a:t>
            </a:r>
            <a:r>
              <a:rPr kumimoji="0" lang="en-US" altLang="es-ES" sz="11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s. 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X-axis represents three serial cDNA dilutions (10^</a:t>
            </a:r>
            <a:r>
              <a:rPr kumimoji="0" lang="en-US" altLang="es-ES" sz="11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3 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10^</a:t>
            </a:r>
            <a:r>
              <a:rPr kumimoji="0" lang="en-US" altLang="es-ES" sz="11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2 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10^</a:t>
            </a:r>
            <a:r>
              <a:rPr kumimoji="0" lang="en-US" altLang="es-ES" sz="11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the concentrated cDNA (10^</a:t>
            </a:r>
            <a:r>
              <a:rPr kumimoji="0" lang="en-US" altLang="es-ES" sz="11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0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used. Y-axis shows CT obtained. Coefficient of determination (R</a:t>
            </a:r>
            <a:r>
              <a:rPr kumimoji="0" lang="en-US" altLang="es-ES" sz="11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the slopes are also presented. (B). Efficiency graph for all primers tested. (C). Table: Slope and efficiency for each gene (E=10^(</a:t>
            </a:r>
            <a:r>
              <a:rPr kumimoji="0" lang="en-US" altLang="es-ES" sz="11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slope)</a:t>
            </a:r>
            <a:r>
              <a:rPr kumimoji="0" lang="en-US" altLang="es-ES" sz="11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1</a:t>
            </a:r>
            <a:r>
              <a:rPr kumimoji="0" lang="en-US" altLang="es-ES" sz="11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</a:t>
            </a:r>
            <a:endParaRPr kumimoji="0" lang="en-US" altLang="es-E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19529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AA86EC9C-AEAD-9417-2E91-1951899D8A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/>
          </a:p>
        </p:txBody>
      </p:sp>
      <p:sp>
        <p:nvSpPr>
          <p:cNvPr id="3" name="Rectangle 3">
            <a:extLst>
              <a:ext uri="{FF2B5EF4-FFF2-40B4-BE49-F238E27FC236}">
                <a16:creationId xmlns:a16="http://schemas.microsoft.com/office/drawing/2014/main" id="{DE92BF44-EE0F-40DD-957D-1B46BC0039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71311" y="6143017"/>
            <a:ext cx="6622916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329565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329565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329565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329565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329565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329565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329565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329565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3295650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295650" algn="l"/>
              </a:tabLst>
            </a:pPr>
            <a:r>
              <a:rPr kumimoji="0" lang="en-US" altLang="es-ES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. O</a:t>
            </a:r>
            <a:r>
              <a:rPr kumimoji="0" lang="en-US" altLang="es-ES" sz="1000" b="1" i="0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kumimoji="0" lang="en-US" altLang="es-ES" sz="1000" b="1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kumimoji="0" lang="en-US" altLang="es-ES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ccumulation in anther and pistil i</a:t>
            </a:r>
            <a:r>
              <a:rPr kumimoji="0" lang="en-US" altLang="es-ES" sz="1000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 HS contrasting rapeseed varieties</a:t>
            </a:r>
            <a:r>
              <a:rPr kumimoji="0" lang="en-US" altLang="es-ES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295650" algn="l"/>
              </a:tabLst>
            </a:pPr>
            <a:r>
              <a:rPr kumimoji="0" lang="en-US" altLang="es-E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</a:t>
            </a:r>
            <a:r>
              <a:rPr kumimoji="0" lang="en-US" altLang="es-ES" sz="1000" b="0" i="0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</a:t>
            </a:r>
            <a:r>
              <a:rPr kumimoji="0" lang="en-US" altLang="es-ES" sz="10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 </a:t>
            </a:r>
            <a:r>
              <a:rPr kumimoji="0" lang="en-US" altLang="es-ES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cumulation in anther (A) and pistil (B) estimated by NBT staining. SAFI5 and DH13, grown under non-stress (22/18º C) or heat-stress conditions (35/22ºC) for three days at flowering stage Bars represent 1 mm.</a:t>
            </a:r>
            <a:endParaRPr kumimoji="0" lang="en-US" altLang="es-E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D8A8A074-7DE6-2AFE-AE9F-FF3089A3F604}"/>
              </a:ext>
            </a:extLst>
          </p:cNvPr>
          <p:cNvSpPr txBox="1"/>
          <p:nvPr/>
        </p:nvSpPr>
        <p:spPr>
          <a:xfrm>
            <a:off x="4096543" y="378847"/>
            <a:ext cx="3112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F8252B26-539A-9187-D959-F9510480F299}"/>
              </a:ext>
            </a:extLst>
          </p:cNvPr>
          <p:cNvSpPr txBox="1"/>
          <p:nvPr/>
        </p:nvSpPr>
        <p:spPr>
          <a:xfrm>
            <a:off x="4045907" y="3199518"/>
            <a:ext cx="3883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</a:p>
        </p:txBody>
      </p:sp>
      <p:pic>
        <p:nvPicPr>
          <p:cNvPr id="9" name="Imagen 8">
            <a:extLst>
              <a:ext uri="{FF2B5EF4-FFF2-40B4-BE49-F238E27FC236}">
                <a16:creationId xmlns:a16="http://schemas.microsoft.com/office/drawing/2014/main" id="{3B8AC5EB-7ED8-8110-A609-F8B462CCB2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84919" y="247864"/>
            <a:ext cx="4096867" cy="58953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85199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</TotalTime>
  <Words>180</Words>
  <Application>Microsoft Office PowerPoint</Application>
  <PresentationFormat>Widescreen</PresentationFormat>
  <Paragraphs>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Times New Roman</vt:lpstr>
      <vt:lpstr>Tema de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OAQUIN MEDINA ALCAZAR</dc:creator>
  <cp:lastModifiedBy>Valiollah Mohammadi</cp:lastModifiedBy>
  <cp:revision>4</cp:revision>
  <dcterms:created xsi:type="dcterms:W3CDTF">2024-11-22T06:48:37Z</dcterms:created>
  <dcterms:modified xsi:type="dcterms:W3CDTF">2025-01-11T10:34:28Z</dcterms:modified>
</cp:coreProperties>
</file>